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A02071-B9F7-4D2D-A384-6DC341A5CBC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250E89-9798-49D0-AD90-7975EDB201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71DCE6-91F3-4C3A-82C3-FB364D5D25B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97A870-8C91-4667-97A3-FD9DF4D456C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42B0DE-2F78-4354-A3BE-D1791747CD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60B0E8-E316-480D-A73D-CD5CC8C395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EDF97E-2631-4157-9EF0-85F6E4CEE0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FB7C4B-F1F8-4BBB-A433-871645089B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87827A-7AF1-4E9E-9BDE-3547F07538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537E84-F8F4-4EC7-B578-8291AFF562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33FED3-BB08-4058-9D7F-BA16608030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7E7C22-84F4-4AFE-9CD2-56FE4B4EE4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4C2BBF-AA67-4396-A324-E17D11D2CE7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0" y="0"/>
            <a:ext cx="4648320" cy="348624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4495680" y="0"/>
            <a:ext cx="4648320" cy="3486240"/>
          </a:xfrm>
          <a:prstGeom prst="rect">
            <a:avLst/>
          </a:prstGeom>
          <a:ln w="0">
            <a:noFill/>
          </a:ln>
        </p:spPr>
      </p:pic>
      <p:grpSp>
        <p:nvGrpSpPr>
          <p:cNvPr id="43" name=""/>
          <p:cNvGrpSpPr/>
          <p:nvPr/>
        </p:nvGrpSpPr>
        <p:grpSpPr>
          <a:xfrm>
            <a:off x="1602720" y="4648320"/>
            <a:ext cx="6198840" cy="1450080"/>
            <a:chOff x="1602720" y="4648320"/>
            <a:chExt cx="6198840" cy="1450080"/>
          </a:xfrm>
        </p:grpSpPr>
        <p:sp>
          <p:nvSpPr>
            <p:cNvPr id="44" name=""/>
            <p:cNvSpPr/>
            <p:nvPr/>
          </p:nvSpPr>
          <p:spPr>
            <a:xfrm>
              <a:off x="1602720" y="4648320"/>
              <a:ext cx="1322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Eukaryote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6403320" y="4724280"/>
              <a:ext cx="1398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Prokaryote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737520" y="5181480"/>
              <a:ext cx="1840320" cy="91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Bottom View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80% Consensu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Protein: 1UV6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0" y="0"/>
            <a:ext cx="4572000" cy="3429000"/>
          </a:xfrm>
          <a:prstGeom prst="rect">
            <a:avLst/>
          </a:prstGeom>
          <a:ln w="0">
            <a:noFill/>
          </a:ln>
        </p:spPr>
      </p:pic>
      <p:pic>
        <p:nvPicPr>
          <p:cNvPr id="48" name="" descr=""/>
          <p:cNvPicPr/>
          <p:nvPr/>
        </p:nvPicPr>
        <p:blipFill>
          <a:blip r:embed="rId2"/>
          <a:stretch/>
        </p:blipFill>
        <p:spPr>
          <a:xfrm>
            <a:off x="4572000" y="0"/>
            <a:ext cx="4572000" cy="3429000"/>
          </a:xfrm>
          <a:prstGeom prst="rect">
            <a:avLst/>
          </a:prstGeom>
          <a:ln w="0">
            <a:noFill/>
          </a:ln>
        </p:spPr>
      </p:pic>
      <p:grpSp>
        <p:nvGrpSpPr>
          <p:cNvPr id="49" name=""/>
          <p:cNvGrpSpPr/>
          <p:nvPr/>
        </p:nvGrpSpPr>
        <p:grpSpPr>
          <a:xfrm>
            <a:off x="1602720" y="4724280"/>
            <a:ext cx="6198840" cy="1450080"/>
            <a:chOff x="1602720" y="4724280"/>
            <a:chExt cx="6198840" cy="1450080"/>
          </a:xfrm>
        </p:grpSpPr>
        <p:sp>
          <p:nvSpPr>
            <p:cNvPr id="50" name=""/>
            <p:cNvSpPr/>
            <p:nvPr/>
          </p:nvSpPr>
          <p:spPr>
            <a:xfrm>
              <a:off x="1602720" y="4724280"/>
              <a:ext cx="1322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Eukaryote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6403320" y="4800240"/>
              <a:ext cx="1398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Prokaryote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216960" y="5257440"/>
              <a:ext cx="2881080" cy="91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Side View [Chain C and D]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80% Consensu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Protein: 1UV6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8-11T20:02:45Z</dcterms:created>
  <dc:creator>tasneem</dc:creator>
  <dc:description/>
  <dc:language>en-US</dc:language>
  <cp:lastModifiedBy>aravind</cp:lastModifiedBy>
  <dcterms:modified xsi:type="dcterms:W3CDTF">2004-08-12T03:50:32Z</dcterms:modified>
  <cp:revision>1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r8>1328117776</vt:r8>
  </property>
  <property fmtid="{D5CDD505-2E9C-101B-9397-08002B2CF9AE}" pid="3" name="_AuthorEmail">
    <vt:lpwstr>tasneem@ncbi.nlm.nih.gov</vt:lpwstr>
  </property>
  <property fmtid="{D5CDD505-2E9C-101B-9397-08002B2CF9AE}" pid="4" name="_AuthorEmailDisplayName">
    <vt:lpwstr>Tasneem, Asba (NIH/NLM/NCBI)</vt:lpwstr>
  </property>
  <property fmtid="{D5CDD505-2E9C-101B-9397-08002B2CF9AE}" pid="5" name="_EmailSubject">
    <vt:lpwstr>References</vt:lpwstr>
  </property>
  <property fmtid="{D5CDD505-2E9C-101B-9397-08002B2CF9AE}" pid="6" name="_NewReviewCycle">
    <vt:lpwstr/>
  </property>
  <property fmtid="{D5CDD505-2E9C-101B-9397-08002B2CF9AE}" pid="7" name="_ReviewingToolsShownOnce">
    <vt:lpwstr/>
  </property>
</Properties>
</file>